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98" d="100"/>
          <a:sy n="98" d="100"/>
        </p:scale>
        <p:origin x="110" y="8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1_Aktuell\02_Publikationen\A_Cellular_Biotech\Liu_2015\Figure_2\raw_data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1_Aktuell\02_Publikationen\A_Cellular_Biotech\Liu_2015\Figure_2\raw_data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Tabelle2!$J$2</c:f>
              <c:strCache>
                <c:ptCount val="1"/>
                <c:pt idx="0">
                  <c:v>WT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x"/>
            <c:errBarType val="both"/>
            <c:errValType val="fixedVal"/>
            <c:noEndCap val="0"/>
            <c:val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y"/>
            <c:errBarType val="both"/>
            <c:errValType val="cust"/>
            <c:noEndCap val="0"/>
            <c:plus>
              <c:numRef>
                <c:f>Tabelle2!$L$3:$L$6</c:f>
                <c:numCache>
                  <c:formatCode>General</c:formatCode>
                  <c:ptCount val="4"/>
                  <c:pt idx="0">
                    <c:v>0.3</c:v>
                  </c:pt>
                  <c:pt idx="1">
                    <c:v>2.2999999999999998</c:v>
                  </c:pt>
                  <c:pt idx="2">
                    <c:v>2.1</c:v>
                  </c:pt>
                  <c:pt idx="3">
                    <c:v>2.4</c:v>
                  </c:pt>
                </c:numCache>
              </c:numRef>
            </c:plus>
            <c:minus>
              <c:numRef>
                <c:f>Tabelle2!$L$3:$L$6</c:f>
                <c:numCache>
                  <c:formatCode>General</c:formatCode>
                  <c:ptCount val="4"/>
                  <c:pt idx="0">
                    <c:v>0.3</c:v>
                  </c:pt>
                  <c:pt idx="1">
                    <c:v>2.2999999999999998</c:v>
                  </c:pt>
                  <c:pt idx="2">
                    <c:v>2.1</c:v>
                  </c:pt>
                  <c:pt idx="3">
                    <c:v>2.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Tabelle2!$I$3:$I$6</c:f>
              <c:numCache>
                <c:formatCode>General</c:formatCode>
                <c:ptCount val="4"/>
                <c:pt idx="0">
                  <c:v>0</c:v>
                </c:pt>
                <c:pt idx="1">
                  <c:v>50</c:v>
                </c:pt>
                <c:pt idx="2">
                  <c:v>100</c:v>
                </c:pt>
                <c:pt idx="3">
                  <c:v>150</c:v>
                </c:pt>
              </c:numCache>
            </c:numRef>
          </c:xVal>
          <c:yVal>
            <c:numRef>
              <c:f>Tabelle2!$J$3:$J$6</c:f>
              <c:numCache>
                <c:formatCode>General</c:formatCode>
                <c:ptCount val="4"/>
                <c:pt idx="0">
                  <c:v>5</c:v>
                </c:pt>
                <c:pt idx="1">
                  <c:v>22</c:v>
                </c:pt>
                <c:pt idx="2">
                  <c:v>49</c:v>
                </c:pt>
                <c:pt idx="3">
                  <c:v>6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F4B-43D6-AEB8-F32DA91B5037}"/>
            </c:ext>
          </c:extLst>
        </c:ser>
        <c:ser>
          <c:idx val="1"/>
          <c:order val="1"/>
          <c:tx>
            <c:strRef>
              <c:f>Tabelle2!$K$2</c:f>
              <c:strCache>
                <c:ptCount val="1"/>
                <c:pt idx="0">
                  <c:v>TPC1a ox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x"/>
            <c:errBarType val="both"/>
            <c:errValType val="fixedVal"/>
            <c:noEndCap val="0"/>
            <c:val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y"/>
            <c:errBarType val="both"/>
            <c:errValType val="cust"/>
            <c:noEndCap val="0"/>
            <c:plus>
              <c:numRef>
                <c:f>Tabelle2!$M$3:$M$6</c:f>
                <c:numCache>
                  <c:formatCode>General</c:formatCode>
                  <c:ptCount val="4"/>
                  <c:pt idx="0">
                    <c:v>0.9</c:v>
                  </c:pt>
                  <c:pt idx="1">
                    <c:v>2.2000000000000002</c:v>
                  </c:pt>
                  <c:pt idx="2">
                    <c:v>3.9</c:v>
                  </c:pt>
                  <c:pt idx="3">
                    <c:v>3.5</c:v>
                  </c:pt>
                </c:numCache>
              </c:numRef>
            </c:plus>
            <c:minus>
              <c:numRef>
                <c:f>Tabelle2!$M$3:$M$6</c:f>
                <c:numCache>
                  <c:formatCode>General</c:formatCode>
                  <c:ptCount val="4"/>
                  <c:pt idx="0">
                    <c:v>0.9</c:v>
                  </c:pt>
                  <c:pt idx="1">
                    <c:v>2.2000000000000002</c:v>
                  </c:pt>
                  <c:pt idx="2">
                    <c:v>3.9</c:v>
                  </c:pt>
                  <c:pt idx="3">
                    <c:v>3.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Tabelle2!$I$3:$I$6</c:f>
              <c:numCache>
                <c:formatCode>General</c:formatCode>
                <c:ptCount val="4"/>
                <c:pt idx="0">
                  <c:v>0</c:v>
                </c:pt>
                <c:pt idx="1">
                  <c:v>50</c:v>
                </c:pt>
                <c:pt idx="2">
                  <c:v>100</c:v>
                </c:pt>
                <c:pt idx="3">
                  <c:v>150</c:v>
                </c:pt>
              </c:numCache>
            </c:numRef>
          </c:xVal>
          <c:yVal>
            <c:numRef>
              <c:f>Tabelle2!$K$3:$K$6</c:f>
              <c:numCache>
                <c:formatCode>General</c:formatCode>
                <c:ptCount val="4"/>
                <c:pt idx="0">
                  <c:v>4</c:v>
                </c:pt>
                <c:pt idx="1">
                  <c:v>13</c:v>
                </c:pt>
                <c:pt idx="2">
                  <c:v>39</c:v>
                </c:pt>
                <c:pt idx="3">
                  <c:v>5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9F4B-43D6-AEB8-F32DA91B503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89203119"/>
        <c:axId val="1889203535"/>
      </c:scatterChart>
      <c:valAx>
        <c:axId val="1889203119"/>
        <c:scaling>
          <c:orientation val="minMax"/>
          <c:max val="15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1889203535"/>
        <c:crosses val="autoZero"/>
        <c:crossBetween val="midCat"/>
      </c:valAx>
      <c:valAx>
        <c:axId val="1889203535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1889203119"/>
        <c:crosses val="autoZero"/>
        <c:crossBetween val="midCat"/>
      </c:valAx>
      <c:spPr>
        <a:noFill/>
        <a:ln w="25400"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[raw_data.xlsx]Tabelle2!$J$2</c:f>
              <c:strCache>
                <c:ptCount val="1"/>
                <c:pt idx="0">
                  <c:v>WT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x"/>
            <c:errBarType val="both"/>
            <c:errValType val="fixedVal"/>
            <c:noEndCap val="0"/>
            <c:val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y"/>
            <c:errBarType val="both"/>
            <c:errValType val="cust"/>
            <c:noEndCap val="0"/>
            <c:plus>
              <c:numRef>
                <c:f>[raw_data.xlsx]Tabelle2!$L$3:$L$6</c:f>
                <c:numCache>
                  <c:formatCode>General</c:formatCode>
                  <c:ptCount val="4"/>
                  <c:pt idx="0">
                    <c:v>2.5</c:v>
                  </c:pt>
                  <c:pt idx="1">
                    <c:v>4.3</c:v>
                  </c:pt>
                  <c:pt idx="2">
                    <c:v>2.1</c:v>
                  </c:pt>
                  <c:pt idx="3">
                    <c:v>1.9</c:v>
                  </c:pt>
                </c:numCache>
              </c:numRef>
            </c:plus>
            <c:minus>
              <c:numRef>
                <c:f>[raw_data.xlsx]Tabelle2!$L$3:$L$6</c:f>
                <c:numCache>
                  <c:formatCode>General</c:formatCode>
                  <c:ptCount val="4"/>
                  <c:pt idx="0">
                    <c:v>2.5</c:v>
                  </c:pt>
                  <c:pt idx="1">
                    <c:v>4.3</c:v>
                  </c:pt>
                  <c:pt idx="2">
                    <c:v>2.1</c:v>
                  </c:pt>
                  <c:pt idx="3">
                    <c:v>1.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[raw_data.xlsx]Tabelle2!$I$3:$I$6</c:f>
              <c:numCache>
                <c:formatCode>General</c:formatCode>
                <c:ptCount val="4"/>
                <c:pt idx="0">
                  <c:v>0</c:v>
                </c:pt>
                <c:pt idx="1">
                  <c:v>50</c:v>
                </c:pt>
                <c:pt idx="2">
                  <c:v>100</c:v>
                </c:pt>
                <c:pt idx="3">
                  <c:v>150</c:v>
                </c:pt>
              </c:numCache>
            </c:numRef>
          </c:xVal>
          <c:yVal>
            <c:numRef>
              <c:f>[raw_data.xlsx]Tabelle2!$J$3:$J$6</c:f>
              <c:numCache>
                <c:formatCode>General</c:formatCode>
                <c:ptCount val="4"/>
                <c:pt idx="0">
                  <c:v>100</c:v>
                </c:pt>
                <c:pt idx="1">
                  <c:v>87</c:v>
                </c:pt>
                <c:pt idx="2">
                  <c:v>32</c:v>
                </c:pt>
                <c:pt idx="3">
                  <c:v>1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1CB-4DC6-9651-108CE97DDCF3}"/>
            </c:ext>
          </c:extLst>
        </c:ser>
        <c:ser>
          <c:idx val="1"/>
          <c:order val="1"/>
          <c:tx>
            <c:strRef>
              <c:f>[raw_data.xlsx]Tabelle2!$K$2</c:f>
              <c:strCache>
                <c:ptCount val="1"/>
                <c:pt idx="0">
                  <c:v>TPC1a ox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x"/>
            <c:errBarType val="both"/>
            <c:errValType val="fixedVal"/>
            <c:noEndCap val="0"/>
            <c:val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errBars>
            <c:errDir val="y"/>
            <c:errBarType val="both"/>
            <c:errValType val="cust"/>
            <c:noEndCap val="0"/>
            <c:plus>
              <c:numRef>
                <c:f>[raw_data.xlsx]Tabelle2!$M$3:$M$6</c:f>
                <c:numCache>
                  <c:formatCode>General</c:formatCode>
                  <c:ptCount val="4"/>
                  <c:pt idx="0">
                    <c:v>3.2</c:v>
                  </c:pt>
                  <c:pt idx="1">
                    <c:v>8.6999999999999993</c:v>
                  </c:pt>
                  <c:pt idx="2">
                    <c:v>4.9000000000000004</c:v>
                  </c:pt>
                  <c:pt idx="3">
                    <c:v>0.9</c:v>
                  </c:pt>
                </c:numCache>
              </c:numRef>
            </c:plus>
            <c:minus>
              <c:numRef>
                <c:f>[raw_data.xlsx]Tabelle2!$M$3:$M$6</c:f>
                <c:numCache>
                  <c:formatCode>General</c:formatCode>
                  <c:ptCount val="4"/>
                  <c:pt idx="0">
                    <c:v>3.2</c:v>
                  </c:pt>
                  <c:pt idx="1">
                    <c:v>8.6999999999999993</c:v>
                  </c:pt>
                  <c:pt idx="2">
                    <c:v>4.9000000000000004</c:v>
                  </c:pt>
                  <c:pt idx="3">
                    <c:v>0.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[raw_data.xlsx]Tabelle2!$I$3:$I$6</c:f>
              <c:numCache>
                <c:formatCode>General</c:formatCode>
                <c:ptCount val="4"/>
                <c:pt idx="0">
                  <c:v>0</c:v>
                </c:pt>
                <c:pt idx="1">
                  <c:v>50</c:v>
                </c:pt>
                <c:pt idx="2">
                  <c:v>100</c:v>
                </c:pt>
                <c:pt idx="3">
                  <c:v>150</c:v>
                </c:pt>
              </c:numCache>
            </c:numRef>
          </c:xVal>
          <c:yVal>
            <c:numRef>
              <c:f>[raw_data.xlsx]Tabelle2!$K$3:$K$6</c:f>
              <c:numCache>
                <c:formatCode>General</c:formatCode>
                <c:ptCount val="4"/>
                <c:pt idx="0">
                  <c:v>102</c:v>
                </c:pt>
                <c:pt idx="1">
                  <c:v>91</c:v>
                </c:pt>
                <c:pt idx="2">
                  <c:v>38</c:v>
                </c:pt>
                <c:pt idx="3">
                  <c:v>2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51CB-4DC6-9651-108CE97DDCF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89203119"/>
        <c:axId val="1889203535"/>
      </c:scatterChart>
      <c:valAx>
        <c:axId val="1889203119"/>
        <c:scaling>
          <c:orientation val="minMax"/>
          <c:max val="15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1889203535"/>
        <c:crosses val="autoZero"/>
        <c:crossBetween val="midCat"/>
      </c:valAx>
      <c:valAx>
        <c:axId val="1889203535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1889203119"/>
        <c:crosses val="autoZero"/>
        <c:crossBetween val="midCat"/>
        <c:majorUnit val="20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E875681-BDBF-6197-9AD4-2980E9C45A8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07C78158-BDE6-8840-B244-2BA0579BDFB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C14C299-733D-48F0-6F75-43BCAB5DCA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F720C-8328-4BD6-820C-326D5B5258A7}" type="datetimeFigureOut">
              <a:rPr lang="de-DE" smtClean="0"/>
              <a:t>05.08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257667B-F775-7AD8-D801-A3B43D636C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234AFFC-C500-B9D1-4B86-C15E4067F7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986AB-BC2F-4C67-B0DE-CD0704056C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604683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CE9A14B-61E2-7745-C38A-B8524FBE94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DBE78D81-2D9D-B03A-9C73-6616CD54671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F6FDAAB-7193-AFC5-CCF8-CB19BE2F5A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F720C-8328-4BD6-820C-326D5B5258A7}" type="datetimeFigureOut">
              <a:rPr lang="de-DE" smtClean="0"/>
              <a:t>05.08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4F21F112-3DB5-BCD7-A791-8610ABB882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573DB0E-EA55-AB3B-0D62-D522980603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986AB-BC2F-4C67-B0DE-CD0704056C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41107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0A2BFA4E-6FE4-7179-2756-2B42743C1F2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ED059E5F-3A82-D805-0A5B-5A33A8EDD1B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CE80FE14-CF8B-11CC-C4A5-99A9A20D10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F720C-8328-4BD6-820C-326D5B5258A7}" type="datetimeFigureOut">
              <a:rPr lang="de-DE" smtClean="0"/>
              <a:t>05.08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ED32E69-A0C4-F0B9-5E31-1B8957152A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49ECE7F-1326-7453-72C0-5BA4A6BC59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986AB-BC2F-4C67-B0DE-CD0704056C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098343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DC289FF-18B7-1B9A-C762-DFF9D2760E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88B5D9F9-74C3-56B2-F7A9-96CDF4499AB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B2C2DC7-BF22-7944-6848-3E97949F82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F720C-8328-4BD6-820C-326D5B5258A7}" type="datetimeFigureOut">
              <a:rPr lang="de-DE" smtClean="0"/>
              <a:t>05.08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BD8FB6D5-4927-FAC3-B5ED-AD702CEC25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1957577-21F4-7788-5B19-AD93F5A586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986AB-BC2F-4C67-B0DE-CD0704056C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050883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710D690-9312-5EB6-0924-7935381C27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0BE223F8-6E1E-E516-0D72-59F95CC2EF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F0DDC5E-C55A-0D48-7D90-FD6A777B56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F720C-8328-4BD6-820C-326D5B5258A7}" type="datetimeFigureOut">
              <a:rPr lang="de-DE" smtClean="0"/>
              <a:t>05.08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B2B4713-F8C2-996A-4BBF-D6EF637E9C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91A534A-F73A-BDB6-11A1-71ABFDF2A8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986AB-BC2F-4C67-B0DE-CD0704056C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426619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8CA1BE6-DA7F-C410-47E7-1979EC9B76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CB4AAEDA-7C02-30FE-FD3D-A28FF6EF721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5AEE183A-A135-8066-0EE0-B859F9EC2A4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A6E1BD11-EC84-543F-A394-D8EB41D462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F720C-8328-4BD6-820C-326D5B5258A7}" type="datetimeFigureOut">
              <a:rPr lang="de-DE" smtClean="0"/>
              <a:t>05.08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F4CEEE18-CFFB-2044-96B6-D44F7EDEEC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D4332D4C-ADEC-CFE7-5BA0-F6C90BE5A5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986AB-BC2F-4C67-B0DE-CD0704056C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828720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876BD67-8FF4-DA34-9743-5119D8C808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864AC65E-6A8F-1766-515A-B986A045D7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DB740D0F-790B-324F-8161-CE52D75B2C8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BA751BBB-6D57-8F32-EDC1-D03D8E1671F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B3818DF0-32E2-EA55-A9D0-81610129712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32A9C2EF-AF04-DBE8-08D2-897476CAEA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F720C-8328-4BD6-820C-326D5B5258A7}" type="datetimeFigureOut">
              <a:rPr lang="de-DE" smtClean="0"/>
              <a:t>05.08.2025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B8B4A429-36D0-CF97-5428-21F216D443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4A8FCA9A-2F59-863A-11FE-C40345BCE0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986AB-BC2F-4C67-B0DE-CD0704056C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779499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1F48328-963A-02AE-AA35-C158AE46E0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7652D0F9-97FB-25EE-7111-ECDCB79655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F720C-8328-4BD6-820C-326D5B5258A7}" type="datetimeFigureOut">
              <a:rPr lang="de-DE" smtClean="0"/>
              <a:t>05.08.2025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03247E25-B6FB-1047-86F4-33587B73D5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40E7ED05-BDEC-5052-0219-F0D590E1E4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986AB-BC2F-4C67-B0DE-CD0704056C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901522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08C8B0DC-1CF7-A3DA-7C5E-8944AB40DF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F720C-8328-4BD6-820C-326D5B5258A7}" type="datetimeFigureOut">
              <a:rPr lang="de-DE" smtClean="0"/>
              <a:t>05.08.2025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F86B27B7-EE96-460C-B79C-C22E2435D4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1494B1BB-D4BF-0F4C-6144-910926E0BE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986AB-BC2F-4C67-B0DE-CD0704056C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401982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CF56BD5-B5A7-5162-DB29-90B3D22F34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54036BD0-646E-A7BB-76F6-F257257F626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5A4B4A33-38AE-405A-B1B4-573CA9A30F9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B0645305-E66F-C1D5-12D7-29CFC1F238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F720C-8328-4BD6-820C-326D5B5258A7}" type="datetimeFigureOut">
              <a:rPr lang="de-DE" smtClean="0"/>
              <a:t>05.08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DE5F7844-3555-7256-ACF7-8C2C0200B4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C7EC5EB9-6521-509A-665F-755E612BDF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986AB-BC2F-4C67-B0DE-CD0704056C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480066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0C7F5B5-00E3-E04D-0CCE-85E0A8D4BB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61DED3ED-612C-BC23-8DF5-7D2C5174926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BC347843-0BEA-1A38-7FCF-FEA01857570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4CE1BDB5-9795-FE72-9A97-BFAD7D363D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3F720C-8328-4BD6-820C-326D5B5258A7}" type="datetimeFigureOut">
              <a:rPr lang="de-DE" smtClean="0"/>
              <a:t>05.08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02A356D5-0A1B-6EBE-36BB-41F373447B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2EF58EAF-6D53-0E2E-2DDC-10245CA88C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986AB-BC2F-4C67-B0DE-CD0704056C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821800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7A347B84-C902-FF4C-2C6A-64A8574012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6374B6D1-DF3F-BB5A-22AC-996D1A6C00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AC77488-C918-9FD7-7F05-D6EFBB04DDB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3F720C-8328-4BD6-820C-326D5B5258A7}" type="datetimeFigureOut">
              <a:rPr lang="de-DE" smtClean="0"/>
              <a:t>05.08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816C12E-FB79-39EF-12A5-7510880AAEE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22B9181-E761-DD25-D3C0-49C1B7D1420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A986AB-BC2F-4C67-B0DE-CD0704056C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110789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Diagramm 3">
            <a:extLst>
              <a:ext uri="{FF2B5EF4-FFF2-40B4-BE49-F238E27FC236}">
                <a16:creationId xmlns:a16="http://schemas.microsoft.com/office/drawing/2014/main" id="{F34F930C-A4BB-E6EE-2B54-D20C63E3762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36643155"/>
              </p:ext>
            </p:extLst>
          </p:nvPr>
        </p:nvGraphicFramePr>
        <p:xfrm>
          <a:off x="6701595" y="1914525"/>
          <a:ext cx="316992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feld 4">
            <a:extLst>
              <a:ext uri="{FF2B5EF4-FFF2-40B4-BE49-F238E27FC236}">
                <a16:creationId xmlns:a16="http://schemas.microsoft.com/office/drawing/2014/main" id="{9973B943-52A5-074C-736E-3F803B35E0F1}"/>
              </a:ext>
            </a:extLst>
          </p:cNvPr>
          <p:cNvSpPr txBox="1"/>
          <p:nvPr/>
        </p:nvSpPr>
        <p:spPr>
          <a:xfrm>
            <a:off x="7723612" y="4737036"/>
            <a:ext cx="12876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/>
              <a:t>NaCl [</a:t>
            </a:r>
            <a:r>
              <a:rPr lang="de-DE" sz="1600" b="1" dirty="0" err="1"/>
              <a:t>mM</a:t>
            </a:r>
            <a:r>
              <a:rPr lang="de-DE" sz="1600" b="1" dirty="0"/>
              <a:t>]</a:t>
            </a: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D045CE9C-9AAA-1482-B189-B700AF1BF490}"/>
              </a:ext>
            </a:extLst>
          </p:cNvPr>
          <p:cNvSpPr txBox="1"/>
          <p:nvPr/>
        </p:nvSpPr>
        <p:spPr>
          <a:xfrm rot="16200000">
            <a:off x="5576965" y="2962891"/>
            <a:ext cx="17728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 err="1"/>
              <a:t>mortality</a:t>
            </a:r>
            <a:r>
              <a:rPr lang="de-DE" sz="1600" b="1" dirty="0"/>
              <a:t> [%]</a:t>
            </a:r>
          </a:p>
        </p:txBody>
      </p:sp>
      <p:graphicFrame>
        <p:nvGraphicFramePr>
          <p:cNvPr id="8" name="Diagramm 7">
            <a:extLst>
              <a:ext uri="{FF2B5EF4-FFF2-40B4-BE49-F238E27FC236}">
                <a16:creationId xmlns:a16="http://schemas.microsoft.com/office/drawing/2014/main" id="{F34F930C-A4BB-E6EE-2B54-D20C63E3762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80920777"/>
              </p:ext>
            </p:extLst>
          </p:nvPr>
        </p:nvGraphicFramePr>
        <p:xfrm>
          <a:off x="2853690" y="1914525"/>
          <a:ext cx="316992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9" name="Textfeld 8">
            <a:extLst>
              <a:ext uri="{FF2B5EF4-FFF2-40B4-BE49-F238E27FC236}">
                <a16:creationId xmlns:a16="http://schemas.microsoft.com/office/drawing/2014/main" id="{8B99792F-992D-ACE6-58C3-0BB0941B3825}"/>
              </a:ext>
            </a:extLst>
          </p:cNvPr>
          <p:cNvSpPr txBox="1"/>
          <p:nvPr/>
        </p:nvSpPr>
        <p:spPr>
          <a:xfrm>
            <a:off x="3913612" y="4737036"/>
            <a:ext cx="12876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/>
              <a:t>NaCl [</a:t>
            </a:r>
            <a:r>
              <a:rPr lang="de-DE" sz="1600" b="1" dirty="0" err="1"/>
              <a:t>mM</a:t>
            </a:r>
            <a:r>
              <a:rPr lang="de-DE" sz="1600" b="1" dirty="0"/>
              <a:t>]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5FAABF2D-6463-9D8B-ACD1-F5A7BF7FA833}"/>
              </a:ext>
            </a:extLst>
          </p:cNvPr>
          <p:cNvSpPr txBox="1"/>
          <p:nvPr/>
        </p:nvSpPr>
        <p:spPr>
          <a:xfrm rot="16200000">
            <a:off x="1624674" y="2907296"/>
            <a:ext cx="20002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/>
              <a:t>PCV [% </a:t>
            </a:r>
            <a:r>
              <a:rPr lang="de-DE" sz="1600" b="1" dirty="0" err="1"/>
              <a:t>of</a:t>
            </a:r>
            <a:r>
              <a:rPr lang="de-DE" sz="1600" b="1" dirty="0"/>
              <a:t> WT, 0 </a:t>
            </a:r>
            <a:r>
              <a:rPr lang="de-DE" sz="1600" b="1" dirty="0" err="1"/>
              <a:t>mM</a:t>
            </a:r>
            <a:r>
              <a:rPr lang="de-DE" sz="1600" b="1" dirty="0"/>
              <a:t>]</a:t>
            </a:r>
          </a:p>
        </p:txBody>
      </p:sp>
      <p:sp>
        <p:nvSpPr>
          <p:cNvPr id="12" name="Freihandform: Form 11">
            <a:extLst>
              <a:ext uri="{FF2B5EF4-FFF2-40B4-BE49-F238E27FC236}">
                <a16:creationId xmlns:a16="http://schemas.microsoft.com/office/drawing/2014/main" id="{5A3DE706-0C0C-9B09-ED3E-805E7FB1BA8E}"/>
              </a:ext>
            </a:extLst>
          </p:cNvPr>
          <p:cNvSpPr/>
          <p:nvPr/>
        </p:nvSpPr>
        <p:spPr>
          <a:xfrm>
            <a:off x="3343275" y="2428875"/>
            <a:ext cx="2409825" cy="1466850"/>
          </a:xfrm>
          <a:custGeom>
            <a:avLst/>
            <a:gdLst>
              <a:gd name="connsiteX0" fmla="*/ 0 w 2409825"/>
              <a:gd name="connsiteY0" fmla="*/ 0 h 1466850"/>
              <a:gd name="connsiteX1" fmla="*/ 828675 w 2409825"/>
              <a:gd name="connsiteY1" fmla="*/ 219075 h 1466850"/>
              <a:gd name="connsiteX2" fmla="*/ 1609725 w 2409825"/>
              <a:gd name="connsiteY2" fmla="*/ 1190625 h 1466850"/>
              <a:gd name="connsiteX3" fmla="*/ 2409825 w 2409825"/>
              <a:gd name="connsiteY3" fmla="*/ 1466850 h 14668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409825" h="1466850">
                <a:moveTo>
                  <a:pt x="0" y="0"/>
                </a:moveTo>
                <a:cubicBezTo>
                  <a:pt x="280194" y="10319"/>
                  <a:pt x="560388" y="20638"/>
                  <a:pt x="828675" y="219075"/>
                </a:cubicBezTo>
                <a:cubicBezTo>
                  <a:pt x="1096962" y="417512"/>
                  <a:pt x="1346200" y="982663"/>
                  <a:pt x="1609725" y="1190625"/>
                </a:cubicBezTo>
                <a:cubicBezTo>
                  <a:pt x="1873250" y="1398587"/>
                  <a:pt x="2141537" y="1432718"/>
                  <a:pt x="2409825" y="1466850"/>
                </a:cubicBezTo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FE54A588-F074-77BE-E86B-0AB3BA52148E}"/>
              </a:ext>
            </a:extLst>
          </p:cNvPr>
          <p:cNvSpPr txBox="1"/>
          <p:nvPr/>
        </p:nvSpPr>
        <p:spPr>
          <a:xfrm>
            <a:off x="2455521" y="1317561"/>
            <a:ext cx="40237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b="1" dirty="0"/>
              <a:t>A</a:t>
            </a: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4A2C66D9-CB65-109A-7B2E-F0BD296633BF}"/>
              </a:ext>
            </a:extLst>
          </p:cNvPr>
          <p:cNvSpPr txBox="1"/>
          <p:nvPr/>
        </p:nvSpPr>
        <p:spPr>
          <a:xfrm>
            <a:off x="6275046" y="1317561"/>
            <a:ext cx="40237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b="1" dirty="0"/>
              <a:t>B</a:t>
            </a:r>
          </a:p>
        </p:txBody>
      </p:sp>
      <p:sp>
        <p:nvSpPr>
          <p:cNvPr id="15" name="Freihandform: Form 14">
            <a:extLst>
              <a:ext uri="{FF2B5EF4-FFF2-40B4-BE49-F238E27FC236}">
                <a16:creationId xmlns:a16="http://schemas.microsoft.com/office/drawing/2014/main" id="{E82D8667-DF71-F23B-FFD1-4773ACD61E95}"/>
              </a:ext>
            </a:extLst>
          </p:cNvPr>
          <p:cNvSpPr/>
          <p:nvPr/>
        </p:nvSpPr>
        <p:spPr>
          <a:xfrm>
            <a:off x="7124700" y="2438400"/>
            <a:ext cx="2486025" cy="1685925"/>
          </a:xfrm>
          <a:custGeom>
            <a:avLst/>
            <a:gdLst>
              <a:gd name="connsiteX0" fmla="*/ 0 w 2486025"/>
              <a:gd name="connsiteY0" fmla="*/ 1685925 h 1685925"/>
              <a:gd name="connsiteX1" fmla="*/ 800100 w 2486025"/>
              <a:gd name="connsiteY1" fmla="*/ 1228725 h 1685925"/>
              <a:gd name="connsiteX2" fmla="*/ 1790700 w 2486025"/>
              <a:gd name="connsiteY2" fmla="*/ 400050 h 1685925"/>
              <a:gd name="connsiteX3" fmla="*/ 2486025 w 2486025"/>
              <a:gd name="connsiteY3" fmla="*/ 0 h 16859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486025" h="1685925">
                <a:moveTo>
                  <a:pt x="0" y="1685925"/>
                </a:moveTo>
                <a:cubicBezTo>
                  <a:pt x="250825" y="1564481"/>
                  <a:pt x="501650" y="1443038"/>
                  <a:pt x="800100" y="1228725"/>
                </a:cubicBezTo>
                <a:cubicBezTo>
                  <a:pt x="1098550" y="1014412"/>
                  <a:pt x="1509713" y="604837"/>
                  <a:pt x="1790700" y="400050"/>
                </a:cubicBezTo>
                <a:cubicBezTo>
                  <a:pt x="2071688" y="195262"/>
                  <a:pt x="2278856" y="97631"/>
                  <a:pt x="2486025" y="0"/>
                </a:cubicBezTo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6" name="Freihandform: Form 15">
            <a:extLst>
              <a:ext uri="{FF2B5EF4-FFF2-40B4-BE49-F238E27FC236}">
                <a16:creationId xmlns:a16="http://schemas.microsoft.com/office/drawing/2014/main" id="{79EDF5D3-97E3-B68B-B26B-5EB8BBC0BD4C}"/>
              </a:ext>
            </a:extLst>
          </p:cNvPr>
          <p:cNvSpPr/>
          <p:nvPr/>
        </p:nvSpPr>
        <p:spPr>
          <a:xfrm>
            <a:off x="7124700" y="2638425"/>
            <a:ext cx="2457450" cy="1495425"/>
          </a:xfrm>
          <a:custGeom>
            <a:avLst/>
            <a:gdLst>
              <a:gd name="connsiteX0" fmla="*/ 0 w 2457450"/>
              <a:gd name="connsiteY0" fmla="*/ 1495425 h 1495425"/>
              <a:gd name="connsiteX1" fmla="*/ 809625 w 2457450"/>
              <a:gd name="connsiteY1" fmla="*/ 1247775 h 1495425"/>
              <a:gd name="connsiteX2" fmla="*/ 1676400 w 2457450"/>
              <a:gd name="connsiteY2" fmla="*/ 561975 h 1495425"/>
              <a:gd name="connsiteX3" fmla="*/ 1676400 w 2457450"/>
              <a:gd name="connsiteY3" fmla="*/ 561975 h 1495425"/>
              <a:gd name="connsiteX4" fmla="*/ 2457450 w 2457450"/>
              <a:gd name="connsiteY4" fmla="*/ 0 h 14954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457450" h="1495425">
                <a:moveTo>
                  <a:pt x="0" y="1495425"/>
                </a:moveTo>
                <a:cubicBezTo>
                  <a:pt x="265112" y="1449387"/>
                  <a:pt x="530225" y="1403350"/>
                  <a:pt x="809625" y="1247775"/>
                </a:cubicBezTo>
                <a:cubicBezTo>
                  <a:pt x="1089025" y="1092200"/>
                  <a:pt x="1676400" y="561975"/>
                  <a:pt x="1676400" y="561975"/>
                </a:cubicBezTo>
                <a:lnTo>
                  <a:pt x="1676400" y="561975"/>
                </a:lnTo>
                <a:lnTo>
                  <a:pt x="2457450" y="0"/>
                </a:lnTo>
              </a:path>
            </a:pathLst>
          </a:cu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972AC100-9072-AD8C-7FEA-4E8E5701C95B}"/>
              </a:ext>
            </a:extLst>
          </p:cNvPr>
          <p:cNvSpPr txBox="1"/>
          <p:nvPr/>
        </p:nvSpPr>
        <p:spPr>
          <a:xfrm>
            <a:off x="3406743" y="3396928"/>
            <a:ext cx="14673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WT=</a:t>
            </a:r>
            <a:r>
              <a:rPr lang="de-DE" sz="1200" i="1" dirty="0"/>
              <a:t>Nt</a:t>
            </a:r>
            <a:r>
              <a:rPr lang="de-DE" sz="1200" dirty="0"/>
              <a:t>TPC1A-GFPox</a:t>
            </a: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D22BE756-794E-FC32-0B81-31A4C6103530}"/>
              </a:ext>
            </a:extLst>
          </p:cNvPr>
          <p:cNvSpPr txBox="1"/>
          <p:nvPr/>
        </p:nvSpPr>
        <p:spPr>
          <a:xfrm>
            <a:off x="8037633" y="2906686"/>
            <a:ext cx="3962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WT</a:t>
            </a: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1CF65C5B-91F1-A013-BA93-42DD9A86AC1F}"/>
              </a:ext>
            </a:extLst>
          </p:cNvPr>
          <p:cNvSpPr txBox="1"/>
          <p:nvPr/>
        </p:nvSpPr>
        <p:spPr>
          <a:xfrm>
            <a:off x="8273642" y="3607641"/>
            <a:ext cx="16002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1200" i="1" dirty="0"/>
              <a:t>Nt</a:t>
            </a:r>
            <a:r>
              <a:rPr lang="de-DE" sz="1200" dirty="0"/>
              <a:t>TPC1A-GFPox</a:t>
            </a:r>
          </a:p>
        </p:txBody>
      </p:sp>
      <p:sp>
        <p:nvSpPr>
          <p:cNvPr id="21" name="Textfeld 20">
            <a:extLst>
              <a:ext uri="{FF2B5EF4-FFF2-40B4-BE49-F238E27FC236}">
                <a16:creationId xmlns:a16="http://schemas.microsoft.com/office/drawing/2014/main" id="{4E9A0336-0783-8653-062A-DB03C684F320}"/>
              </a:ext>
            </a:extLst>
          </p:cNvPr>
          <p:cNvSpPr txBox="1"/>
          <p:nvPr/>
        </p:nvSpPr>
        <p:spPr>
          <a:xfrm>
            <a:off x="7771237" y="3920804"/>
            <a:ext cx="38458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1200" dirty="0"/>
              <a:t>**</a:t>
            </a:r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7BD5B451-B7CC-6861-76E5-2B2AACB29EF3}"/>
              </a:ext>
            </a:extLst>
          </p:cNvPr>
          <p:cNvSpPr txBox="1"/>
          <p:nvPr/>
        </p:nvSpPr>
        <p:spPr>
          <a:xfrm>
            <a:off x="8651059" y="3271450"/>
            <a:ext cx="38458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1200" dirty="0"/>
              <a:t>*</a:t>
            </a:r>
          </a:p>
        </p:txBody>
      </p:sp>
      <p:sp>
        <p:nvSpPr>
          <p:cNvPr id="23" name="Textfeld 22">
            <a:extLst>
              <a:ext uri="{FF2B5EF4-FFF2-40B4-BE49-F238E27FC236}">
                <a16:creationId xmlns:a16="http://schemas.microsoft.com/office/drawing/2014/main" id="{203B24B4-9545-4BAF-7A72-53FD8E4301CA}"/>
              </a:ext>
            </a:extLst>
          </p:cNvPr>
          <p:cNvSpPr txBox="1"/>
          <p:nvPr/>
        </p:nvSpPr>
        <p:spPr>
          <a:xfrm>
            <a:off x="9462492" y="2705581"/>
            <a:ext cx="38458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1200" dirty="0"/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24290886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8</Words>
  <Application>Microsoft Office PowerPoint</Application>
  <PresentationFormat>Breitbild</PresentationFormat>
  <Paragraphs>12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Nick, Peter (BOTANIK)</dc:creator>
  <cp:lastModifiedBy>Peter Nick</cp:lastModifiedBy>
  <cp:revision>4</cp:revision>
  <dcterms:created xsi:type="dcterms:W3CDTF">2022-11-29T06:15:03Z</dcterms:created>
  <dcterms:modified xsi:type="dcterms:W3CDTF">2025-08-05T09:14:32Z</dcterms:modified>
</cp:coreProperties>
</file>